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3944" y="-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999F2-69E4-484C-BD4B-225FE2AC1FD7}" type="datetimeFigureOut">
              <a:rPr lang="fr-FR" smtClean="0"/>
              <a:t>24/06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8706-2A31-1043-B991-6457FF3475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04520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999F2-69E4-484C-BD4B-225FE2AC1FD7}" type="datetimeFigureOut">
              <a:rPr lang="fr-FR" smtClean="0"/>
              <a:t>24/06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8706-2A31-1043-B991-6457FF3475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07892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999F2-69E4-484C-BD4B-225FE2AC1FD7}" type="datetimeFigureOut">
              <a:rPr lang="fr-FR" smtClean="0"/>
              <a:t>24/06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8706-2A31-1043-B991-6457FF3475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3864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999F2-69E4-484C-BD4B-225FE2AC1FD7}" type="datetimeFigureOut">
              <a:rPr lang="fr-FR" smtClean="0"/>
              <a:t>24/06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8706-2A31-1043-B991-6457FF3475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7965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999F2-69E4-484C-BD4B-225FE2AC1FD7}" type="datetimeFigureOut">
              <a:rPr lang="fr-FR" smtClean="0"/>
              <a:t>24/06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8706-2A31-1043-B991-6457FF3475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1272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999F2-69E4-484C-BD4B-225FE2AC1FD7}" type="datetimeFigureOut">
              <a:rPr lang="fr-FR" smtClean="0"/>
              <a:t>24/06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8706-2A31-1043-B991-6457FF3475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63644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999F2-69E4-484C-BD4B-225FE2AC1FD7}" type="datetimeFigureOut">
              <a:rPr lang="fr-FR" smtClean="0"/>
              <a:t>24/06/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8706-2A31-1043-B991-6457FF3475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12262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999F2-69E4-484C-BD4B-225FE2AC1FD7}" type="datetimeFigureOut">
              <a:rPr lang="fr-FR" smtClean="0"/>
              <a:t>24/06/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8706-2A31-1043-B991-6457FF3475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079490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999F2-69E4-484C-BD4B-225FE2AC1FD7}" type="datetimeFigureOut">
              <a:rPr lang="fr-FR" smtClean="0"/>
              <a:t>24/06/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8706-2A31-1043-B991-6457FF3475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61018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999F2-69E4-484C-BD4B-225FE2AC1FD7}" type="datetimeFigureOut">
              <a:rPr lang="fr-FR" smtClean="0"/>
              <a:t>24/06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8706-2A31-1043-B991-6457FF3475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5182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999F2-69E4-484C-BD4B-225FE2AC1FD7}" type="datetimeFigureOut">
              <a:rPr lang="fr-FR" smtClean="0"/>
              <a:t>24/06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8706-2A31-1043-B991-6457FF3475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31154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9999F2-69E4-484C-BD4B-225FE2AC1FD7}" type="datetimeFigureOut">
              <a:rPr lang="fr-FR" smtClean="0"/>
              <a:t>24/06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838706-2A31-1043-B991-6457FF34750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0982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Image 57" descr="HDMEC VEGF effects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1516"/>
          <a:stretch/>
        </p:blipFill>
        <p:spPr>
          <a:xfrm>
            <a:off x="1048598" y="3955763"/>
            <a:ext cx="5118512" cy="2159988"/>
          </a:xfrm>
          <a:prstGeom prst="rect">
            <a:avLst/>
          </a:prstGeom>
        </p:spPr>
      </p:pic>
      <p:pic>
        <p:nvPicPr>
          <p:cNvPr id="59" name="Image 58" descr="HDMEC VEGF effects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/>
        </p:blipFill>
        <p:spPr>
          <a:xfrm>
            <a:off x="1184063" y="6257740"/>
            <a:ext cx="4963363" cy="2159999"/>
          </a:xfrm>
          <a:prstGeom prst="rect">
            <a:avLst/>
          </a:prstGeom>
        </p:spPr>
      </p:pic>
      <p:sp>
        <p:nvSpPr>
          <p:cNvPr id="30" name="TextBox 145">
            <a:extLst>
              <a:ext uri="{FF2B5EF4-FFF2-40B4-BE49-F238E27FC236}">
                <a16:creationId xmlns="" xmlns:a16="http://schemas.microsoft.com/office/drawing/2014/main" id="{474577C9-C5D8-8D48-B914-D6342EFF20BF}"/>
              </a:ext>
            </a:extLst>
          </p:cNvPr>
          <p:cNvSpPr txBox="1"/>
          <p:nvPr/>
        </p:nvSpPr>
        <p:spPr>
          <a:xfrm>
            <a:off x="5574855" y="37487"/>
            <a:ext cx="14085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 smtClean="0">
                <a:latin typeface="Arial"/>
                <a:cs typeface="Arial"/>
              </a:rPr>
              <a:t>Figure S1</a:t>
            </a:r>
            <a:endParaRPr lang="x-none" sz="1600" b="1" dirty="0">
              <a:latin typeface="Arial"/>
              <a:cs typeface="Arial"/>
            </a:endParaRPr>
          </a:p>
        </p:txBody>
      </p:sp>
      <p:sp>
        <p:nvSpPr>
          <p:cNvPr id="5" name="TextBox 145">
            <a:extLst>
              <a:ext uri="{FF2B5EF4-FFF2-40B4-BE49-F238E27FC236}">
                <a16:creationId xmlns="" xmlns:a16="http://schemas.microsoft.com/office/drawing/2014/main" id="{474577C9-C5D8-8D48-B914-D6342EFF20BF}"/>
              </a:ext>
            </a:extLst>
          </p:cNvPr>
          <p:cNvSpPr txBox="1"/>
          <p:nvPr/>
        </p:nvSpPr>
        <p:spPr>
          <a:xfrm>
            <a:off x="-519275" y="3656987"/>
            <a:ext cx="1408546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100" b="1" dirty="0" smtClean="0">
                <a:latin typeface="Arial"/>
                <a:cs typeface="Arial"/>
              </a:rPr>
              <a:t>b</a:t>
            </a:r>
            <a:endParaRPr lang="x-none" sz="2100" b="1" dirty="0">
              <a:latin typeface="Arial"/>
              <a:cs typeface="Arial"/>
            </a:endParaRPr>
          </a:p>
        </p:txBody>
      </p:sp>
      <p:sp>
        <p:nvSpPr>
          <p:cNvPr id="6" name="TextBox 145">
            <a:extLst>
              <a:ext uri="{FF2B5EF4-FFF2-40B4-BE49-F238E27FC236}">
                <a16:creationId xmlns="" xmlns:a16="http://schemas.microsoft.com/office/drawing/2014/main" id="{474577C9-C5D8-8D48-B914-D6342EFF20BF}"/>
              </a:ext>
            </a:extLst>
          </p:cNvPr>
          <p:cNvSpPr txBox="1"/>
          <p:nvPr/>
        </p:nvSpPr>
        <p:spPr>
          <a:xfrm>
            <a:off x="-519275" y="490341"/>
            <a:ext cx="1408546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100" b="1" dirty="0" smtClean="0">
                <a:latin typeface="Arial"/>
                <a:cs typeface="Arial"/>
              </a:rPr>
              <a:t>a</a:t>
            </a:r>
            <a:endParaRPr lang="x-none" sz="2100" b="1" dirty="0">
              <a:latin typeface="Arial"/>
              <a:cs typeface="Arial"/>
            </a:endParaRPr>
          </a:p>
        </p:txBody>
      </p:sp>
      <p:grpSp>
        <p:nvGrpSpPr>
          <p:cNvPr id="20" name="Grouper 19"/>
          <p:cNvGrpSpPr/>
          <p:nvPr/>
        </p:nvGrpSpPr>
        <p:grpSpPr>
          <a:xfrm>
            <a:off x="-198288" y="744926"/>
            <a:ext cx="4146336" cy="2364400"/>
            <a:chOff x="-198288" y="744926"/>
            <a:chExt cx="4146336" cy="2364400"/>
          </a:xfrm>
        </p:grpSpPr>
        <p:cxnSp>
          <p:nvCxnSpPr>
            <p:cNvPr id="26" name="Connecteur droit 25"/>
            <p:cNvCxnSpPr/>
            <p:nvPr/>
          </p:nvCxnSpPr>
          <p:spPr>
            <a:xfrm>
              <a:off x="3441073" y="2363628"/>
              <a:ext cx="166306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necteur droit 30"/>
            <p:cNvCxnSpPr/>
            <p:nvPr/>
          </p:nvCxnSpPr>
          <p:spPr>
            <a:xfrm>
              <a:off x="3441073" y="2630328"/>
              <a:ext cx="166306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" name="Connecteur droit 2"/>
            <p:cNvCxnSpPr/>
            <p:nvPr/>
          </p:nvCxnSpPr>
          <p:spPr>
            <a:xfrm>
              <a:off x="3428373" y="1982628"/>
              <a:ext cx="166306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>
              <a:off x="-198288" y="1999331"/>
              <a:ext cx="136811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GF</a:t>
              </a:r>
              <a:r>
                <a:rPr lang="en-US" sz="9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5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 rot="16200000">
              <a:off x="1038459" y="1628868"/>
              <a:ext cx="375088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T  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 rot="16200000">
              <a:off x="1166672" y="1483516"/>
              <a:ext cx="71659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FGFRinh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 rot="16200000">
              <a:off x="1386646" y="1445114"/>
              <a:ext cx="971196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RPIN340  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 rot="16200000">
              <a:off x="1668278" y="1432414"/>
              <a:ext cx="971196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HINX31  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 rot="16200000">
              <a:off x="2116791" y="1590358"/>
              <a:ext cx="680708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GF 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 rot="16200000">
              <a:off x="2117694" y="1286461"/>
              <a:ext cx="123770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GF + </a:t>
              </a:r>
              <a:r>
                <a:rPr lang="en-US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FGFRinh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 rot="16200000">
              <a:off x="2414480" y="1248361"/>
              <a:ext cx="123770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GF + SRPIN340 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 rot="16200000">
              <a:off x="2720397" y="1248361"/>
              <a:ext cx="123770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GF + SPHINX31 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>
              <a:off x="-198288" y="2589942"/>
              <a:ext cx="136811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>
              <a:off x="3466919" y="1830228"/>
              <a:ext cx="481129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>
              <a:off x="3466919" y="2222052"/>
              <a:ext cx="481129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4" name="Image 2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48972" y="1905825"/>
              <a:ext cx="2682207" cy="50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2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>
              <a:off x="3466919" y="2501452"/>
              <a:ext cx="481129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145">
              <a:extLst>
                <a:ext uri="{FF2B5EF4-FFF2-40B4-BE49-F238E27FC236}">
                  <a16:creationId xmlns="" xmlns:a16="http://schemas.microsoft.com/office/drawing/2014/main" id="{474577C9-C5D8-8D48-B914-D6342EFF20BF}"/>
                </a:ext>
              </a:extLst>
            </p:cNvPr>
            <p:cNvSpPr txBox="1"/>
            <p:nvPr/>
          </p:nvSpPr>
          <p:spPr>
            <a:xfrm>
              <a:off x="1515828" y="2832327"/>
              <a:ext cx="14085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smtClean="0">
                  <a:latin typeface="Arial"/>
                  <a:cs typeface="Arial"/>
                </a:rPr>
                <a:t>HUVEC</a:t>
              </a:r>
              <a:endParaRPr lang="x-none" sz="1200" b="1" dirty="0">
                <a:latin typeface="Arial"/>
                <a:cs typeface="Arial"/>
              </a:endParaRPr>
            </a:p>
          </p:txBody>
        </p:sp>
        <p:pic>
          <p:nvPicPr>
            <p:cNvPr id="2" name="Image 1"/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48972" y="2501452"/>
              <a:ext cx="2699994" cy="324000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</p:grpSp>
      <p:grpSp>
        <p:nvGrpSpPr>
          <p:cNvPr id="21" name="Grouper 20"/>
          <p:cNvGrpSpPr/>
          <p:nvPr/>
        </p:nvGrpSpPr>
        <p:grpSpPr>
          <a:xfrm>
            <a:off x="3664099" y="744341"/>
            <a:ext cx="3230349" cy="2364985"/>
            <a:chOff x="3664099" y="744341"/>
            <a:chExt cx="3230349" cy="2364985"/>
          </a:xfrm>
        </p:grpSpPr>
        <p:cxnSp>
          <p:nvCxnSpPr>
            <p:cNvPr id="36" name="Connecteur droit 35"/>
            <p:cNvCxnSpPr/>
            <p:nvPr/>
          </p:nvCxnSpPr>
          <p:spPr>
            <a:xfrm>
              <a:off x="6387473" y="2300128"/>
              <a:ext cx="166306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Connecteur droit 36"/>
            <p:cNvCxnSpPr/>
            <p:nvPr/>
          </p:nvCxnSpPr>
          <p:spPr>
            <a:xfrm>
              <a:off x="6387473" y="2617628"/>
              <a:ext cx="166306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Connecteur droit 37"/>
            <p:cNvCxnSpPr/>
            <p:nvPr/>
          </p:nvCxnSpPr>
          <p:spPr>
            <a:xfrm>
              <a:off x="6374773" y="1969928"/>
              <a:ext cx="166306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>
              <a:off x="6413319" y="1817528"/>
              <a:ext cx="481129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>
              <a:off x="6413319" y="2158552"/>
              <a:ext cx="481129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>
              <a:off x="6413319" y="2488752"/>
              <a:ext cx="481129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145">
              <a:extLst>
                <a:ext uri="{FF2B5EF4-FFF2-40B4-BE49-F238E27FC236}">
                  <a16:creationId xmlns="" xmlns:a16="http://schemas.microsoft.com/office/drawing/2014/main" id="{474577C9-C5D8-8D48-B914-D6342EFF20BF}"/>
                </a:ext>
              </a:extLst>
            </p:cNvPr>
            <p:cNvSpPr txBox="1"/>
            <p:nvPr/>
          </p:nvSpPr>
          <p:spPr>
            <a:xfrm>
              <a:off x="4942080" y="2832327"/>
              <a:ext cx="14085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smtClean="0">
                  <a:latin typeface="Arial"/>
                  <a:cs typeface="Arial"/>
                </a:rPr>
                <a:t>HDMEC</a:t>
              </a:r>
              <a:endParaRPr lang="x-none" sz="1200" b="1" dirty="0">
                <a:latin typeface="Arial"/>
                <a:cs typeface="Arial"/>
              </a:endParaRPr>
            </a:p>
          </p:txBody>
        </p:sp>
        <p:sp>
          <p:nvSpPr>
            <p:cNvPr id="28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 rot="16200000">
              <a:off x="4925512" y="1628283"/>
              <a:ext cx="375088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T  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 rot="16200000">
              <a:off x="5051344" y="1589773"/>
              <a:ext cx="680708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GF 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 rot="16200000">
              <a:off x="5052247" y="1298576"/>
              <a:ext cx="123770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GF + </a:t>
              </a:r>
              <a:r>
                <a:rPr lang="en-US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FGFRinh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 rot="16200000">
              <a:off x="5336333" y="1260476"/>
              <a:ext cx="123770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GF + SRPIN340 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 rot="16200000">
              <a:off x="5616850" y="1247776"/>
              <a:ext cx="123770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GF + SPHINX31 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" name="Image 6"/>
            <p:cNvPicPr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695474" y="1905825"/>
              <a:ext cx="1691999" cy="504000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pic>
          <p:nvPicPr>
            <p:cNvPr id="17" name="Image 16"/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682774" y="2501455"/>
              <a:ext cx="1691999" cy="323997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sp>
          <p:nvSpPr>
            <p:cNvPr id="42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>
              <a:off x="3664099" y="1999331"/>
              <a:ext cx="136811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GF</a:t>
              </a:r>
              <a:r>
                <a:rPr lang="en-US" sz="9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5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ZoneTexte 133">
              <a:extLst>
                <a:ext uri="{FF2B5EF4-FFF2-40B4-BE49-F238E27FC236}">
                  <a16:creationId xmlns:a16="http://schemas.microsoft.com/office/drawing/2014/main" xmlns="" id="{3CEDDE9B-A7E8-494C-8A1A-D9F8ED45FFBD}"/>
                </a:ext>
              </a:extLst>
            </p:cNvPr>
            <p:cNvSpPr txBox="1"/>
            <p:nvPr/>
          </p:nvSpPr>
          <p:spPr>
            <a:xfrm>
              <a:off x="3664099" y="2589942"/>
              <a:ext cx="136811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6497523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</TotalTime>
  <Words>41</Words>
  <Application>Microsoft Macintosh PowerPoint</Application>
  <PresentationFormat>Présentation à l'écran 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eatrice eymin</dc:creator>
  <cp:lastModifiedBy>beatrice eymin</cp:lastModifiedBy>
  <cp:revision>35</cp:revision>
  <dcterms:created xsi:type="dcterms:W3CDTF">2020-05-09T16:01:38Z</dcterms:created>
  <dcterms:modified xsi:type="dcterms:W3CDTF">2021-06-24T13:38:45Z</dcterms:modified>
</cp:coreProperties>
</file>